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A1D4FF"/>
    <a:srgbClr val="FF06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200" d="100"/>
          <a:sy n="200" d="100"/>
        </p:scale>
        <p:origin x="-376" y="35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1839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8384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703"/>
            <a:ext cx="1671638" cy="845220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76" y="396703"/>
            <a:ext cx="4900613" cy="845220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829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042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062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76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1901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4635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8143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4976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2844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39946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1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0EA8F-2CC6-834B-9637-B66C2F45E3C5}" type="datetimeFigureOut">
              <a:t>16/0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079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s42p146_GAP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860" y="4668211"/>
            <a:ext cx="2404232" cy="905216"/>
          </a:xfrm>
          <a:prstGeom prst="rect">
            <a:avLst/>
          </a:prstGeom>
        </p:spPr>
      </p:pic>
      <p:pic>
        <p:nvPicPr>
          <p:cNvPr id="6" name="図 5" descr="s42p146_SNP6_Y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860" y="3712200"/>
            <a:ext cx="2404232" cy="905216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4605813" y="5129263"/>
            <a:ext cx="5743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smtClean="0">
                <a:latin typeface="Helvetica"/>
                <a:cs typeface="Helvetica"/>
              </a:rPr>
              <a:t>GAPDH</a:t>
            </a:r>
            <a:endParaRPr lang="en-US" altLang="ja-JP" sz="800" i="1" dirty="0">
              <a:latin typeface="Helvetica"/>
              <a:cs typeface="Helvetica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605813" y="4281760"/>
            <a:ext cx="1223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/>
                <a:cs typeface="Helvetica"/>
              </a:rPr>
              <a:t>Y chromosome </a:t>
            </a:r>
            <a:r>
              <a:rPr kumimoji="1" lang="en-US" altLang="ja-JP" sz="800" dirty="0" smtClean="0">
                <a:latin typeface="Helvetica"/>
                <a:cs typeface="Helvetica"/>
              </a:rPr>
              <a:t>marker</a:t>
            </a:r>
            <a:endParaRPr lang="en-US" altLang="ja-JP" sz="800" dirty="0">
              <a:latin typeface="Helvetica"/>
              <a:cs typeface="Helvetica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821436" y="3352270"/>
            <a:ext cx="8002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Helvetica"/>
                <a:cs typeface="Helvetica"/>
              </a:rPr>
              <a:t>affected fetus</a:t>
            </a:r>
            <a:endParaRPr lang="en-US" altLang="ja-JP" sz="800">
              <a:latin typeface="Helvetica"/>
              <a:cs typeface="Helvetica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925318" y="3352270"/>
            <a:ext cx="36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cow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291776" y="3352270"/>
            <a:ext cx="3499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sire</a:t>
            </a:r>
          </a:p>
        </p:txBody>
      </p:sp>
      <p:cxnSp>
        <p:nvCxnSpPr>
          <p:cNvPr id="16" name="直線コネクタ 15"/>
          <p:cNvCxnSpPr/>
          <p:nvPr/>
        </p:nvCxnSpPr>
        <p:spPr>
          <a:xfrm flipH="1">
            <a:off x="2456978" y="3560371"/>
            <a:ext cx="146834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 flipH="1">
            <a:off x="3984152" y="3560371"/>
            <a:ext cx="282286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 flipH="1">
            <a:off x="4323527" y="3560371"/>
            <a:ext cx="282286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3874517" y="3531796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Helvetica"/>
                <a:cs typeface="Helvetica"/>
              </a:rPr>
              <a:t>10</a:t>
            </a:r>
            <a:endParaRPr lang="en-US" altLang="ja-JP" sz="800">
              <a:latin typeface="Helvetica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050053" y="3531796"/>
            <a:ext cx="2912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11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217417" y="35317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/>
                <a:cs typeface="Helvetica"/>
              </a:rPr>
              <a:t>12</a:t>
            </a:r>
            <a:endParaRPr lang="en-US" altLang="ja-JP" sz="800" dirty="0">
              <a:latin typeface="Helvetica"/>
              <a:cs typeface="Helvetica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4380253" y="3531796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13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397114" y="353179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Helvetica"/>
                <a:cs typeface="Helvetica"/>
              </a:rPr>
              <a:t>1</a:t>
            </a:r>
            <a:endParaRPr lang="en-US" altLang="ja-JP" sz="800">
              <a:latin typeface="Helvetica"/>
              <a:cs typeface="Helvetica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559949" y="3531796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2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726286" y="353179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3</a:t>
            </a: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895470" y="3531796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4</a:t>
            </a: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068157" y="353179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5</a:t>
            </a: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230991" y="3531796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6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403676" y="3531796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7</a:t>
            </a: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572863" y="353179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8</a:t>
            </a: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739198" y="353179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9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219546" y="3530857"/>
            <a:ext cx="2701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>
                <a:latin typeface="Helvetica"/>
                <a:cs typeface="Helvetica"/>
              </a:rPr>
              <a:t>M</a:t>
            </a:r>
          </a:p>
        </p:txBody>
      </p:sp>
      <p:grpSp>
        <p:nvGrpSpPr>
          <p:cNvPr id="2" name="図形グループ 1"/>
          <p:cNvGrpSpPr/>
          <p:nvPr/>
        </p:nvGrpSpPr>
        <p:grpSpPr>
          <a:xfrm>
            <a:off x="1735595" y="3879933"/>
            <a:ext cx="508744" cy="338554"/>
            <a:chOff x="581967" y="6121580"/>
            <a:chExt cx="508744" cy="338554"/>
          </a:xfrm>
        </p:grpSpPr>
        <p:sp>
          <p:nvSpPr>
            <p:cNvPr id="722" name="テキスト ボックス 721"/>
            <p:cNvSpPr txBox="1"/>
            <p:nvPr/>
          </p:nvSpPr>
          <p:spPr>
            <a:xfrm>
              <a:off x="581967" y="6121580"/>
              <a:ext cx="5052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1k bp</a:t>
              </a:r>
              <a:endParaRPr lang="en-US" altLang="ja-JP" sz="800" dirty="0">
                <a:latin typeface="Helvetica"/>
                <a:cs typeface="Helvetica"/>
              </a:endParaRPr>
            </a:p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500 bp</a:t>
              </a:r>
              <a:endParaRPr lang="en-US" altLang="ja-JP" sz="800" dirty="0">
                <a:latin typeface="Helvetica"/>
                <a:cs typeface="Helvetica"/>
              </a:endParaRPr>
            </a:p>
          </p:txBody>
        </p:sp>
        <p:cxnSp>
          <p:nvCxnSpPr>
            <p:cNvPr id="723" name="直線コネクタ 722"/>
            <p:cNvCxnSpPr/>
            <p:nvPr/>
          </p:nvCxnSpPr>
          <p:spPr>
            <a:xfrm flipH="1">
              <a:off x="1018714" y="6246768"/>
              <a:ext cx="7199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4" name="直線コネクタ 723"/>
            <p:cNvCxnSpPr/>
            <p:nvPr/>
          </p:nvCxnSpPr>
          <p:spPr>
            <a:xfrm flipH="1">
              <a:off x="1018714" y="6354718"/>
              <a:ext cx="7199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6" name="図形グループ 725"/>
          <p:cNvGrpSpPr/>
          <p:nvPr/>
        </p:nvGrpSpPr>
        <p:grpSpPr>
          <a:xfrm>
            <a:off x="1735595" y="4835159"/>
            <a:ext cx="508744" cy="338554"/>
            <a:chOff x="581967" y="6121580"/>
            <a:chExt cx="508744" cy="338554"/>
          </a:xfrm>
        </p:grpSpPr>
        <p:sp>
          <p:nvSpPr>
            <p:cNvPr id="745" name="テキスト ボックス 744"/>
            <p:cNvSpPr txBox="1"/>
            <p:nvPr/>
          </p:nvSpPr>
          <p:spPr>
            <a:xfrm>
              <a:off x="581967" y="6121580"/>
              <a:ext cx="5052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1k bp</a:t>
              </a:r>
              <a:endParaRPr lang="en-US" altLang="ja-JP" sz="800" dirty="0">
                <a:latin typeface="Helvetica"/>
                <a:cs typeface="Helvetica"/>
              </a:endParaRPr>
            </a:p>
            <a:p>
              <a:pPr algn="r"/>
              <a:r>
                <a:rPr lang="en-US" altLang="ja-JP" sz="800" dirty="0" smtClean="0">
                  <a:latin typeface="Helvetica"/>
                  <a:cs typeface="Helvetica"/>
                </a:rPr>
                <a:t>500 bp</a:t>
              </a:r>
              <a:endParaRPr lang="en-US" altLang="ja-JP" sz="800" dirty="0">
                <a:latin typeface="Helvetica"/>
                <a:cs typeface="Helvetica"/>
              </a:endParaRPr>
            </a:p>
          </p:txBody>
        </p:sp>
        <p:cxnSp>
          <p:nvCxnSpPr>
            <p:cNvPr id="746" name="直線コネクタ 745"/>
            <p:cNvCxnSpPr/>
            <p:nvPr/>
          </p:nvCxnSpPr>
          <p:spPr>
            <a:xfrm flipH="1">
              <a:off x="1018714" y="6246768"/>
              <a:ext cx="7199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2" name="直線コネクタ 761"/>
            <p:cNvCxnSpPr/>
            <p:nvPr/>
          </p:nvCxnSpPr>
          <p:spPr>
            <a:xfrm flipH="1">
              <a:off x="1018714" y="6354718"/>
              <a:ext cx="7199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63" name="テキスト ボックス 762"/>
          <p:cNvSpPr txBox="1"/>
          <p:nvPr/>
        </p:nvSpPr>
        <p:spPr>
          <a:xfrm>
            <a:off x="4492298" y="9457267"/>
            <a:ext cx="23130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Additional file </a:t>
            </a:r>
            <a:r>
              <a:rPr lang="ja-JP" altLang="ja-JP" sz="1400" dirty="0" smtClean="0"/>
              <a:t>2</a:t>
            </a:r>
            <a:r>
              <a:rPr kumimoji="1" lang="en-US" altLang="ja-JP" sz="1400" dirty="0" smtClean="0"/>
              <a:t>. </a:t>
            </a:r>
            <a:r>
              <a:rPr lang="en-US" altLang="ja-JP" sz="1400" dirty="0" smtClean="0"/>
              <a:t>Sasaki. et al.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79348520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79</TotalTime>
  <Words>39</Words>
  <Application>Microsoft Macintosh PowerPoint</Application>
  <PresentationFormat>A4 210x297 mm</PresentationFormat>
  <Paragraphs>2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saki Shinji</dc:creator>
  <cp:lastModifiedBy>Sasaki Shinji</cp:lastModifiedBy>
  <cp:revision>250</cp:revision>
  <cp:lastPrinted>2016-04-25T04:37:17Z</cp:lastPrinted>
  <dcterms:created xsi:type="dcterms:W3CDTF">2015-07-31T06:51:32Z</dcterms:created>
  <dcterms:modified xsi:type="dcterms:W3CDTF">2016-08-14T09:16:59Z</dcterms:modified>
</cp:coreProperties>
</file>